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6" d="100"/>
          <a:sy n="106" d="100"/>
        </p:scale>
        <p:origin x="414" y="-17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4899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2728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97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74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7599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1575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4775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0105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5431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0423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6085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F0DA4-078F-48D1-83D7-6C2B1186E62B}" type="datetimeFigureOut">
              <a:rPr lang="en-GB" smtClean="0"/>
              <a:t>29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C8CC12-D209-4EE1-ACC3-47257E24EC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3174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A93BBF4-6B94-48B0-8CCA-33AFF8268B0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7993"/>
          <a:stretch/>
        </p:blipFill>
        <p:spPr>
          <a:xfrm>
            <a:off x="340855" y="288220"/>
            <a:ext cx="8508742" cy="120241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F9C97F2-758C-953C-DAEC-8E03A11E967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961"/>
          <a:stretch/>
        </p:blipFill>
        <p:spPr>
          <a:xfrm>
            <a:off x="205945" y="1648214"/>
            <a:ext cx="8643652" cy="108078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3CD88EB-9ACA-3CED-77A2-F09A4192595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6" b="61285"/>
          <a:stretch/>
        </p:blipFill>
        <p:spPr>
          <a:xfrm>
            <a:off x="167576" y="2885362"/>
            <a:ext cx="8720390" cy="98854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8F1D771-A974-1627-3035-E3CEBD73A0C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8330"/>
          <a:stretch/>
        </p:blipFill>
        <p:spPr>
          <a:xfrm>
            <a:off x="129207" y="4030271"/>
            <a:ext cx="8720390" cy="1118434"/>
          </a:xfrm>
          <a:prstGeom prst="rect">
            <a:avLst/>
          </a:prstGeom>
        </p:spPr>
      </p:pic>
      <p:grpSp>
        <p:nvGrpSpPr>
          <p:cNvPr id="6" name="Group 5">
            <a:extLst>
              <a:ext uri="{FF2B5EF4-FFF2-40B4-BE49-F238E27FC236}">
                <a16:creationId xmlns:a16="http://schemas.microsoft.com/office/drawing/2014/main" id="{A707A963-A701-2323-E9E7-72F1A6946DF2}"/>
              </a:ext>
            </a:extLst>
          </p:cNvPr>
          <p:cNvGrpSpPr/>
          <p:nvPr/>
        </p:nvGrpSpPr>
        <p:grpSpPr>
          <a:xfrm>
            <a:off x="20733" y="5543689"/>
            <a:ext cx="2011549" cy="230832"/>
            <a:chOff x="66866" y="5450621"/>
            <a:chExt cx="2011549" cy="230832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932D3FFD-1529-480E-D62E-6B128D767C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41" t="93861" r="78773" b="36"/>
            <a:stretch/>
          </p:blipFill>
          <p:spPr>
            <a:xfrm>
              <a:off x="581216" y="5491890"/>
              <a:ext cx="68580" cy="179071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76117DF-FFD1-9CEF-F307-7158721B8CB0}"/>
                </a:ext>
              </a:extLst>
            </p:cNvPr>
            <p:cNvSpPr txBox="1"/>
            <p:nvPr/>
          </p:nvSpPr>
          <p:spPr>
            <a:xfrm>
              <a:off x="66866" y="5450621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ex</a:t>
              </a:r>
              <a:endParaRPr lang="en-I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F3BE4D7A-C538-9818-0A76-9B25D652FB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438" t="93817" r="71775" b="79"/>
            <a:stretch/>
          </p:blipFill>
          <p:spPr>
            <a:xfrm>
              <a:off x="1300606" y="5491890"/>
              <a:ext cx="68580" cy="179071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1A3EDCD-776D-DBF3-1708-9BA0D10FF8BD}"/>
                </a:ext>
              </a:extLst>
            </p:cNvPr>
            <p:cNvSpPr txBox="1"/>
            <p:nvPr/>
          </p:nvSpPr>
          <p:spPr>
            <a:xfrm>
              <a:off x="615506" y="5450621"/>
              <a:ext cx="709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Female</a:t>
              </a:r>
              <a:endParaRPr lang="en-I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4FF57AB8-F950-A42F-E26F-28F1FB454661}"/>
                </a:ext>
              </a:extLst>
            </p:cNvPr>
            <p:cNvSpPr txBox="1"/>
            <p:nvPr/>
          </p:nvSpPr>
          <p:spPr>
            <a:xfrm>
              <a:off x="1369186" y="5450621"/>
              <a:ext cx="7092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ale</a:t>
              </a:r>
              <a:endParaRPr lang="en-IN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DDB2242F-941B-C928-70BE-9FEF0C3F9237}"/>
              </a:ext>
            </a:extLst>
          </p:cNvPr>
          <p:cNvSpPr txBox="1"/>
          <p:nvPr/>
        </p:nvSpPr>
        <p:spPr>
          <a:xfrm>
            <a:off x="0" y="5845551"/>
            <a:ext cx="8887966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coprint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K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olon cancer from different datasets of colon cancer using th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BioPortal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Genetic alteration data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including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ssens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tion, truncating mutation, amplification, deep deletion are highlighted from four different datasets, A) colon cancer CPTAC-2 Prospective, Cell 2019, B) colon cancer Sidra-LUMC AC-ICAM, Nat Med 2023, C) colorectal adenocarcinoma TCGA, Pan Cancer Atlas, and D) colorectal adenocarcinoma TCGA, Firehose Legacy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120254C-CBA2-905C-7F3D-D85A00631E89}"/>
              </a:ext>
            </a:extLst>
          </p:cNvPr>
          <p:cNvSpPr txBox="1"/>
          <p:nvPr/>
        </p:nvSpPr>
        <p:spPr>
          <a:xfrm>
            <a:off x="20733" y="259448"/>
            <a:ext cx="310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C8C02014-4501-65BE-16BC-2D6A2169815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275" b="45405"/>
          <a:stretch/>
        </p:blipFill>
        <p:spPr>
          <a:xfrm>
            <a:off x="129207" y="5226437"/>
            <a:ext cx="8720390" cy="276999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B64AD2D2-0B86-6CCC-FEAA-73E365756F99}"/>
              </a:ext>
            </a:extLst>
          </p:cNvPr>
          <p:cNvSpPr txBox="1"/>
          <p:nvPr/>
        </p:nvSpPr>
        <p:spPr>
          <a:xfrm>
            <a:off x="20733" y="1470123"/>
            <a:ext cx="310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B91EDB-892E-61A4-2A98-1F5C6747DA41}"/>
              </a:ext>
            </a:extLst>
          </p:cNvPr>
          <p:cNvSpPr txBox="1"/>
          <p:nvPr/>
        </p:nvSpPr>
        <p:spPr>
          <a:xfrm>
            <a:off x="12128" y="2708483"/>
            <a:ext cx="310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1C4E233-4449-B23C-1260-59D28BC30240}"/>
              </a:ext>
            </a:extLst>
          </p:cNvPr>
          <p:cNvSpPr txBox="1"/>
          <p:nvPr/>
        </p:nvSpPr>
        <p:spPr>
          <a:xfrm>
            <a:off x="0" y="3864789"/>
            <a:ext cx="310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018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97</TotalTime>
  <Words>90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INDAM SAIN</dc:creator>
  <cp:lastModifiedBy>Debdut Naskar</cp:lastModifiedBy>
  <cp:revision>11</cp:revision>
  <dcterms:created xsi:type="dcterms:W3CDTF">2023-03-31T02:32:22Z</dcterms:created>
  <dcterms:modified xsi:type="dcterms:W3CDTF">2024-04-29T16:04:41Z</dcterms:modified>
</cp:coreProperties>
</file>